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63" r:id="rId2"/>
    <p:sldId id="266" r:id="rId3"/>
    <p:sldId id="264" r:id="rId4"/>
    <p:sldId id="265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836"/>
    <p:restoredTop sz="94648"/>
  </p:normalViewPr>
  <p:slideViewPr>
    <p:cSldViewPr snapToGrid="0" snapToObjects="1" showGuides="1">
      <p:cViewPr varScale="1">
        <p:scale>
          <a:sx n="111" d="100"/>
          <a:sy n="111" d="100"/>
        </p:scale>
        <p:origin x="240" y="22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76AFA1-0E56-DA45-ABEF-CF94B7B0978B}" type="datetimeFigureOut">
              <a:rPr lang="en-US" smtClean="0"/>
              <a:t>8/15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FD21AD-F0D3-ED46-A10D-C2828FB3D0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922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4F2AE5-F008-B549-BF98-942AD91A850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B46A6DF-4AEF-F148-A25B-8239D26EF4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0E7622-F4F1-974D-B984-CBEAA77978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034C-872D-0749-8C33-C33ABE3A9C6F}" type="datetimeFigureOut">
              <a:rPr lang="en-US" smtClean="0"/>
              <a:t>8/1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C42ED5-551A-9C44-A3DF-734E17D43E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284FB1-3D4D-6D4D-A159-285BDD4090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844AB-6A4C-DA49-8A8F-F8ADB41178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571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2D41FF-C888-E14E-8635-87139F73C1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5DE8356-F0DB-E747-AAAC-F6A98F56F4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CE3DE9-0A38-EC4B-86EB-1929B99BE9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034C-872D-0749-8C33-C33ABE3A9C6F}" type="datetimeFigureOut">
              <a:rPr lang="en-US" smtClean="0"/>
              <a:t>8/1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76DE4B-FD61-104C-A60E-3F4CFA3FD8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3C690F-7531-D244-A4BF-AAFC78261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844AB-6A4C-DA49-8A8F-F8ADB41178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814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50ACF0A-0201-F24F-AD2E-EE1FE67A11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483714-75AA-2F43-9AD1-F232EB523B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6A2ACA-B920-DA4B-BA5D-5B6E23FC9D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034C-872D-0749-8C33-C33ABE3A9C6F}" type="datetimeFigureOut">
              <a:rPr lang="en-US" smtClean="0"/>
              <a:t>8/1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7B7C8F-D432-E747-A7E8-9480D047C4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9F78EE-89BB-C34F-939E-DA518AC81F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844AB-6A4C-DA49-8A8F-F8ADB41178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744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4BAA46-E9B5-4542-BA1B-E60A32A3C3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088820-93EF-F446-83B8-054FD53FED4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8F3F8B-4EDF-944B-A8C6-D80B19D6A1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034C-872D-0749-8C33-C33ABE3A9C6F}" type="datetimeFigureOut">
              <a:rPr lang="en-US" smtClean="0"/>
              <a:t>8/1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5277CA-400C-2A42-B97B-2FBD95B69B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16F551-8051-E04D-AE6F-B29E26C33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844AB-6A4C-DA49-8A8F-F8ADB41178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9633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A595B6-E976-8148-A0A0-F244A405A6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487029-0C85-9245-88FD-D728F95405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8F8C1B-6CAD-7A46-92C0-B25B14CE84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034C-872D-0749-8C33-C33ABE3A9C6F}" type="datetimeFigureOut">
              <a:rPr lang="en-US" smtClean="0"/>
              <a:t>8/1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80F341-887A-914F-8A01-2C275B7EF6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A039BA-807D-9440-85ED-AEA829D464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844AB-6A4C-DA49-8A8F-F8ADB41178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23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79EEFF-8DC0-FB41-A2ED-F86ED54346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ECBD86-FBE3-5E43-BA3A-CCA93C598B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C92489D-8FA4-8B41-88C6-F5F6A0041A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F76A7E-550F-B946-9C41-3B48E6A9F4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034C-872D-0749-8C33-C33ABE3A9C6F}" type="datetimeFigureOut">
              <a:rPr lang="en-US" smtClean="0"/>
              <a:t>8/1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0C5BD4-2A7C-0149-A377-50765EE18B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E1681E-A8A0-2748-B927-4B67E9973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844AB-6A4C-DA49-8A8F-F8ADB41178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374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D84A9E-5881-F941-80CA-CA9947B97A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75CA44-788C-9143-90D0-420F66030D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7AEE8EB-84DF-C04B-A875-C66EB8B58B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C2FE4F5-DA27-6248-96D8-6C978C2DBD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AC4B1EE-6797-974F-BFC3-049BEB1B4C2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F0FF879-41E6-EA48-B190-380A9A1954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034C-872D-0749-8C33-C33ABE3A9C6F}" type="datetimeFigureOut">
              <a:rPr lang="en-US" smtClean="0"/>
              <a:t>8/15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7A8E840-D408-4240-AFA6-27132F1E4D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80DEEA-7D55-3C42-A968-D0B397E7AD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844AB-6A4C-DA49-8A8F-F8ADB41178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712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73F866-3EEC-5F46-A221-1542AB8D44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C509F9D-37B1-CB4C-86F2-B273EE0F9F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034C-872D-0749-8C33-C33ABE3A9C6F}" type="datetimeFigureOut">
              <a:rPr lang="en-US" smtClean="0"/>
              <a:t>8/15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1CFDB8B-0511-D344-9B0B-09C79C690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D4A7A80-C79B-F54C-B053-5B061907F8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844AB-6A4C-DA49-8A8F-F8ADB41178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016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99B5B59-1A50-E14E-A844-72D366022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034C-872D-0749-8C33-C33ABE3A9C6F}" type="datetimeFigureOut">
              <a:rPr lang="en-US" smtClean="0"/>
              <a:t>8/15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0A08B5-F023-F746-92E7-D4A19045D2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8D83317-2057-F94B-996D-115A2EB5E1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844AB-6A4C-DA49-8A8F-F8ADB41178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6927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B3D132-0A0F-A04E-A30B-F0D209B51F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2AFF14-2B29-BA4D-A168-5AE9953A77B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EEA3C3-5F81-DE45-9452-4F2C77B8CD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1D8CA6-8E03-474C-B0A0-AE0042C55E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034C-872D-0749-8C33-C33ABE3A9C6F}" type="datetimeFigureOut">
              <a:rPr lang="en-US" smtClean="0"/>
              <a:t>8/1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623DD5-29B3-6A46-888E-72A1D26F0E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DF8778-6D10-4E49-A0B1-A67BDDAB1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844AB-6A4C-DA49-8A8F-F8ADB41178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92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CAB817-BB57-8347-86DB-2EFBC66043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E123BD9-B912-EC4F-AB52-AD0B4AF950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73B0F7-989B-AA48-8BA8-CEECBCF3BF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9E6CBE-03F8-6546-86F6-118248010F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034C-872D-0749-8C33-C33ABE3A9C6F}" type="datetimeFigureOut">
              <a:rPr lang="en-US" smtClean="0"/>
              <a:t>8/1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81D97E-E066-CC4D-A5AB-DFC82D0C08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548830-934A-B944-8830-FF60D272D5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844AB-6A4C-DA49-8A8F-F8ADB41178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5040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9EF5AA1-ED18-224F-9CC0-65370BF7AD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B3D902-D756-A241-8A6E-E546EB6E6A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0A574E-DB77-6A46-AA1A-26E5231208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65034C-872D-0749-8C33-C33ABE3A9C6F}" type="datetimeFigureOut">
              <a:rPr lang="en-US" smtClean="0"/>
              <a:t>8/1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595D0E-17E1-E442-9D73-0650FF7BB0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FEB161-0D3A-A343-BF3F-C9A820804E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A844AB-6A4C-DA49-8A8F-F8ADB41178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752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2B3B48F-4396-1D44-A6A7-53A7A8F17FD5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167" y="51244"/>
            <a:ext cx="4899765" cy="3377756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C6847DB9-EC9C-C74B-903B-02F9C48AAA00}"/>
              </a:ext>
            </a:extLst>
          </p:cNvPr>
          <p:cNvSpPr/>
          <p:nvPr/>
        </p:nvSpPr>
        <p:spPr>
          <a:xfrm>
            <a:off x="5856514" y="4201820"/>
            <a:ext cx="617026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1. Rarefaction curves of bacterial assemblages from individual samples subjected to (a) Dry-Wet (b) Wet-Dry and (c) Saturation treatments. OTUs were determined by a cutoff value of 97 % sequence similarity.</a:t>
            </a:r>
            <a:r>
              <a:rPr lang="en-US" dirty="0"/>
              <a:t>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0F8A837-6B40-AB4A-A163-258C24175A45}"/>
              </a:ext>
            </a:extLst>
          </p:cNvPr>
          <p:cNvSpPr txBox="1"/>
          <p:nvPr/>
        </p:nvSpPr>
        <p:spPr>
          <a:xfrm>
            <a:off x="102121" y="72017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1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4701617-24E1-2F4B-883D-21DF41950488}"/>
              </a:ext>
            </a:extLst>
          </p:cNvPr>
          <p:cNvSpPr txBox="1"/>
          <p:nvPr/>
        </p:nvSpPr>
        <p:spPr>
          <a:xfrm>
            <a:off x="5500144" y="88823"/>
            <a:ext cx="529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1b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5DA2168-271C-3347-BA64-299BA8579408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0342" y="0"/>
            <a:ext cx="4377287" cy="3648983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67F197F-2CD0-084A-9A1F-616D3BC081BE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3222" y="3389291"/>
            <a:ext cx="4755653" cy="3377755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F1D9158-6139-0941-AE9B-2FE274A1EA01}"/>
              </a:ext>
            </a:extLst>
          </p:cNvPr>
          <p:cNvSpPr txBox="1"/>
          <p:nvPr/>
        </p:nvSpPr>
        <p:spPr>
          <a:xfrm>
            <a:off x="117025" y="3589290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1c</a:t>
            </a:r>
          </a:p>
        </p:txBody>
      </p:sp>
    </p:spTree>
    <p:extLst>
      <p:ext uri="{BB962C8B-B14F-4D97-AF65-F5344CB8AC3E}">
        <p14:creationId xmlns:p14="http://schemas.microsoft.com/office/powerpoint/2010/main" val="665690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 up of a map&#10;&#10;Description automatically generated">
            <a:extLst>
              <a:ext uri="{FF2B5EF4-FFF2-40B4-BE49-F238E27FC236}">
                <a16:creationId xmlns:a16="http://schemas.microsoft.com/office/drawing/2014/main" id="{B8DD2326-7366-8E4F-9A68-446F76AB51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5122" y="196559"/>
            <a:ext cx="4523873" cy="646488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740A09C-5068-0DC8-3647-0813EDCA81D5}"/>
              </a:ext>
            </a:extLst>
          </p:cNvPr>
          <p:cNvSpPr txBox="1"/>
          <p:nvPr/>
        </p:nvSpPr>
        <p:spPr>
          <a:xfrm>
            <a:off x="5824960" y="2079771"/>
            <a:ext cx="609407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Supplementary Figure S2. </a:t>
            </a:r>
            <a:r>
              <a:rPr lang="en-US" sz="1800" kern="1200" dirty="0">
                <a:solidFill>
                  <a:srgbClr val="000000"/>
                </a:solidFill>
                <a:effectLst/>
                <a:ea typeface="DengXian" panose="02010600030101010101" pitchFamily="2" charset="-122"/>
                <a:cs typeface="Arial" panose="020B0604020202020204" pitchFamily="34" charset="0"/>
              </a:rPr>
              <a:t>Ordination plots showing separation of top 100 OTUs by moisture treatments visualized by nonmetric multidimensional scaling (NMDS) of Bray–Curtis distance metrics. The three moisture treatments are shown in blue (Dry-Wet), grey (Saturation), and orange (Wet-Dry)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215232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8B49183F-80AF-7A42-8575-B472475513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2916" y="112734"/>
            <a:ext cx="8692541" cy="5795027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5BC44A7A-0818-B44E-ABF7-53FD70C4A32F}"/>
              </a:ext>
            </a:extLst>
          </p:cNvPr>
          <p:cNvSpPr/>
          <p:nvPr/>
        </p:nvSpPr>
        <p:spPr>
          <a:xfrm>
            <a:off x="769605" y="5907761"/>
            <a:ext cx="1065279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3. Histogram showing the balanced accuracy metrics corresponding to the number of OTUs observed in the Dry-Wet, Saturation or Wet-Dry treatments. The red bars and fonts call out the number of OTUs with a balanced accuracy of &gt; 0.8 for a given moisture condition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40447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close up of a piece of paper&#10;&#10;Description automatically generated">
            <a:extLst>
              <a:ext uri="{FF2B5EF4-FFF2-40B4-BE49-F238E27FC236}">
                <a16:creationId xmlns:a16="http://schemas.microsoft.com/office/drawing/2014/main" id="{5F52B8AB-EA54-5B47-8DC3-B7CB31505CF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60416" y="263047"/>
            <a:ext cx="11687678" cy="5843839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0311978-E34D-9048-A4DD-BF04B593C096}"/>
              </a:ext>
            </a:extLst>
          </p:cNvPr>
          <p:cNvSpPr txBox="1"/>
          <p:nvPr/>
        </p:nvSpPr>
        <p:spPr>
          <a:xfrm>
            <a:off x="0" y="6287441"/>
            <a:ext cx="12703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S4. Metabolites ranked based on their mean variable importance for predicting OTUs under Dry-Wet treatment.</a:t>
            </a:r>
          </a:p>
        </p:txBody>
      </p:sp>
    </p:spTree>
    <p:extLst>
      <p:ext uri="{BB962C8B-B14F-4D97-AF65-F5344CB8AC3E}">
        <p14:creationId xmlns:p14="http://schemas.microsoft.com/office/powerpoint/2010/main" val="17896557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99</TotalTime>
  <Words>165</Words>
  <Application>Microsoft Macintosh PowerPoint</Application>
  <PresentationFormat>Widescreen</PresentationFormat>
  <Paragraphs>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ideep Banerjee</dc:creator>
  <cp:lastModifiedBy>Jaideep Banerjee</cp:lastModifiedBy>
  <cp:revision>30</cp:revision>
  <dcterms:created xsi:type="dcterms:W3CDTF">2019-12-12T16:43:25Z</dcterms:created>
  <dcterms:modified xsi:type="dcterms:W3CDTF">2022-08-15T20:43:44Z</dcterms:modified>
</cp:coreProperties>
</file>